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2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489"/>
    <p:restoredTop sz="94726"/>
  </p:normalViewPr>
  <p:slideViewPr>
    <p:cSldViewPr snapToGrid="0" showGuides="1">
      <p:cViewPr varScale="1">
        <p:scale>
          <a:sx n="90" d="100"/>
          <a:sy n="90" d="100"/>
        </p:scale>
        <p:origin x="4040" y="200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BE89D2-118B-FA48-8E60-76C93D72660B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3B18F9-2814-0C4A-B1EE-C5C6C19D41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3866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3B18F9-2814-0C4A-B1EE-C5C6C19D414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1146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3213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475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569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735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079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892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6329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5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92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26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1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304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47998C70-6E04-4347-9E7D-9864D57E6764}"/>
              </a:ext>
            </a:extLst>
          </p:cNvPr>
          <p:cNvGrpSpPr/>
          <p:nvPr/>
        </p:nvGrpSpPr>
        <p:grpSpPr>
          <a:xfrm>
            <a:off x="239646" y="1097454"/>
            <a:ext cx="6394121" cy="4580041"/>
            <a:chOff x="239646" y="261636"/>
            <a:chExt cx="6394121" cy="4580041"/>
          </a:xfrm>
        </p:grpSpPr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EFBA7DE8-C586-6903-EBFB-F2CB261E0673}"/>
                </a:ext>
              </a:extLst>
            </p:cNvPr>
            <p:cNvGrpSpPr/>
            <p:nvPr/>
          </p:nvGrpSpPr>
          <p:grpSpPr>
            <a:xfrm>
              <a:off x="239646" y="261636"/>
              <a:ext cx="6394121" cy="4580041"/>
              <a:chOff x="239647" y="261636"/>
              <a:chExt cx="4374714" cy="3133561"/>
            </a:xfrm>
          </p:grpSpPr>
          <p:pic>
            <p:nvPicPr>
              <p:cNvPr id="4" name="図 3" descr="雪, 覆い, 座る, 大きい が含まれている画像&#10;&#10;自動的に生成された説明">
                <a:extLst>
                  <a:ext uri="{FF2B5EF4-FFF2-40B4-BE49-F238E27FC236}">
                    <a16:creationId xmlns:a16="http://schemas.microsoft.com/office/drawing/2014/main" id="{29C14EBA-6573-D5EC-E137-7D661BF2FC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9647" y="261636"/>
                <a:ext cx="2164225" cy="153706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5" name="図 4" descr="屋外, 水, 雪, 覆い が含まれている画像&#10;&#10;自動的に生成された説明">
                <a:extLst>
                  <a:ext uri="{FF2B5EF4-FFF2-40B4-BE49-F238E27FC236}">
                    <a16:creationId xmlns:a16="http://schemas.microsoft.com/office/drawing/2014/main" id="{8426B65A-1A70-C039-9D79-B7FC316722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50227" y="261636"/>
                <a:ext cx="2164134" cy="153706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6" name="図 5" descr="フィールド, クマ, 大きい, グループ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8B15B91-2C9D-9C17-AA68-A459347C41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9647" y="1856630"/>
                <a:ext cx="2164225" cy="1538567"/>
              </a:xfrm>
              <a:prstGeom prst="rect">
                <a:avLst/>
              </a:prstGeom>
            </p:spPr>
          </p:pic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129B6032-3512-59D6-6C22-6C2E2E5ED5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09621" y="1653261"/>
                <a:ext cx="13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" name="図 9" descr="自然, 砂浜, 雨, 異なる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424710F-3213-F3F7-743A-9D3A48BAAC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50136" y="1856630"/>
                <a:ext cx="2164225" cy="1538390"/>
              </a:xfrm>
              <a:prstGeom prst="rect">
                <a:avLst/>
              </a:prstGeom>
            </p:spPr>
          </p:pic>
        </p:grp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F5060A36-CA9A-DEBF-48D2-C8376C1BA871}"/>
                </a:ext>
              </a:extLst>
            </p:cNvPr>
            <p:cNvCxnSpPr>
              <a:cxnSpLocks/>
            </p:cNvCxnSpPr>
            <p:nvPr/>
          </p:nvCxnSpPr>
          <p:spPr>
            <a:xfrm>
              <a:off x="2536417" y="4635825"/>
              <a:ext cx="46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F0F62B94-C949-E912-F034-A85EFCE4A687}"/>
                </a:ext>
              </a:extLst>
            </p:cNvPr>
            <p:cNvCxnSpPr>
              <a:cxnSpLocks/>
            </p:cNvCxnSpPr>
            <p:nvPr/>
          </p:nvCxnSpPr>
          <p:spPr>
            <a:xfrm>
              <a:off x="5769526" y="4635825"/>
              <a:ext cx="46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BFC9349C-A3B2-C005-954D-636C8E3F1715}"/>
                </a:ext>
              </a:extLst>
            </p:cNvPr>
            <p:cNvCxnSpPr>
              <a:cxnSpLocks/>
            </p:cNvCxnSpPr>
            <p:nvPr/>
          </p:nvCxnSpPr>
          <p:spPr>
            <a:xfrm>
              <a:off x="5766351" y="2302200"/>
              <a:ext cx="46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75CB518-6330-3264-8036-B77141922054}"/>
              </a:ext>
            </a:extLst>
          </p:cNvPr>
          <p:cNvSpPr txBox="1"/>
          <p:nvPr/>
        </p:nvSpPr>
        <p:spPr>
          <a:xfrm>
            <a:off x="254359" y="1102807"/>
            <a:ext cx="46674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8564D52-7081-DD8F-BBE0-C6D3720634BC}"/>
              </a:ext>
            </a:extLst>
          </p:cNvPr>
          <p:cNvSpPr txBox="1"/>
          <p:nvPr/>
        </p:nvSpPr>
        <p:spPr>
          <a:xfrm>
            <a:off x="3467459" y="1102807"/>
            <a:ext cx="46674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380FD44-AC98-5A74-38AE-810AEB6D55E2}"/>
              </a:ext>
            </a:extLst>
          </p:cNvPr>
          <p:cNvSpPr txBox="1"/>
          <p:nvPr/>
        </p:nvSpPr>
        <p:spPr>
          <a:xfrm>
            <a:off x="254359" y="3443996"/>
            <a:ext cx="46674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B8718B3-F1A9-EB6E-7D5B-271205A808FE}"/>
              </a:ext>
            </a:extLst>
          </p:cNvPr>
          <p:cNvSpPr txBox="1"/>
          <p:nvPr/>
        </p:nvSpPr>
        <p:spPr>
          <a:xfrm>
            <a:off x="3467459" y="3443996"/>
            <a:ext cx="46674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7300B683-652B-08E9-83A0-C1D0E7DEB1D7}"/>
              </a:ext>
            </a:extLst>
          </p:cNvPr>
          <p:cNvCxnSpPr>
            <a:cxnSpLocks/>
          </p:cNvCxnSpPr>
          <p:nvPr/>
        </p:nvCxnSpPr>
        <p:spPr>
          <a:xfrm>
            <a:off x="1332929" y="4235783"/>
            <a:ext cx="86878" cy="63182"/>
          </a:xfrm>
          <a:prstGeom prst="straightConnector1">
            <a:avLst/>
          </a:prstGeom>
          <a:ln w="28575">
            <a:solidFill>
              <a:schemeClr val="tx1"/>
            </a:solidFill>
            <a:headEnd w="lg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000FEB47-C3B3-BC35-9C3F-0C2504F7264C}"/>
              </a:ext>
            </a:extLst>
          </p:cNvPr>
          <p:cNvCxnSpPr>
            <a:cxnSpLocks/>
          </p:cNvCxnSpPr>
          <p:nvPr/>
        </p:nvCxnSpPr>
        <p:spPr>
          <a:xfrm>
            <a:off x="367254" y="4086231"/>
            <a:ext cx="86878" cy="63182"/>
          </a:xfrm>
          <a:prstGeom prst="straightConnector1">
            <a:avLst/>
          </a:prstGeom>
          <a:ln w="28575">
            <a:solidFill>
              <a:schemeClr val="tx1"/>
            </a:solidFill>
            <a:headEnd w="lg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3F4C81F-19E6-A5DD-5E1B-5A3228894AA6}"/>
              </a:ext>
            </a:extLst>
          </p:cNvPr>
          <p:cNvSpPr txBox="1"/>
          <p:nvPr/>
        </p:nvSpPr>
        <p:spPr>
          <a:xfrm>
            <a:off x="281067" y="5884143"/>
            <a:ext cx="623843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Myotube formation in early cultured cell populations derived from Japanese eel muscle tissue. (A, B) Culturing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onfluen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populations in a differentiation medium, a low-serum medium, induces myotube formation. (C, D) Upon detachment of the differentiated cell population using trypsin, numerous fibrous myotubes were observed (indicated by arrowheads). (A, B, C) Scale bars: 100 µm. (D) Scale bar: 50 µm.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1A9C948E-53FB-8287-91E1-26E590F06153}"/>
              </a:ext>
            </a:extLst>
          </p:cNvPr>
          <p:cNvCxnSpPr>
            <a:cxnSpLocks/>
          </p:cNvCxnSpPr>
          <p:nvPr/>
        </p:nvCxnSpPr>
        <p:spPr>
          <a:xfrm flipH="1">
            <a:off x="5052141" y="4064198"/>
            <a:ext cx="110465" cy="63182"/>
          </a:xfrm>
          <a:prstGeom prst="straightConnector1">
            <a:avLst/>
          </a:prstGeom>
          <a:ln w="28575">
            <a:solidFill>
              <a:schemeClr val="tx1"/>
            </a:solidFill>
            <a:headEnd w="lg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1904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95</TotalTime>
  <Words>91</Words>
  <Application>Microsoft Macintosh PowerPoint</Application>
  <PresentationFormat>レター サイズ 8.5x11 インチ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KEDA Daisuke</dc:creator>
  <cp:lastModifiedBy>IKEDA Daisuke</cp:lastModifiedBy>
  <cp:revision>3</cp:revision>
  <cp:lastPrinted>2024-08-07T09:54:35Z</cp:lastPrinted>
  <dcterms:created xsi:type="dcterms:W3CDTF">2024-01-12T09:46:10Z</dcterms:created>
  <dcterms:modified xsi:type="dcterms:W3CDTF">2024-08-10T06:30:15Z</dcterms:modified>
</cp:coreProperties>
</file>